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7B9D08-7B3E-4273-B71B-4F7BB39956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6FACF-C0DB-480B-8CD8-7A70A604CC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9C6B5-007A-49DF-86BC-539FF4FC8A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7739B-0976-4F83-9FF6-BEEEE4960C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B0D1D-AF57-4028-BB37-DD6F1BE7E1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D8957-0D78-4FC2-BD0F-CBC4B034B5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AE626-F0EB-4DD5-A639-3FF521DBD2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AFB61-6264-49F1-9DBD-B23F7443CF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20165-6D58-4011-8A0A-E82F3AA2E9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A81AD-2F1A-4803-86E7-76D2971591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2904F-AD4B-4A1B-8607-E44EA5D6F0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C887F-12FB-4E7B-BEA3-94A4418F59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571C9C-9C7B-4AB7-87C4-175B3FCA36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901880" y="1752480"/>
            <a:ext cx="5641920" cy="2162160"/>
            <a:chOff x="1901880" y="1752480"/>
            <a:chExt cx="5641920" cy="2162160"/>
          </a:xfrm>
        </p:grpSpPr>
        <p:sp>
          <p:nvSpPr>
            <p:cNvPr id="42" name=""/>
            <p:cNvSpPr/>
            <p:nvPr/>
          </p:nvSpPr>
          <p:spPr>
            <a:xfrm>
              <a:off x="3529800" y="2433600"/>
              <a:ext cx="1311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tac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ale and fema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5178240" y="2438280"/>
              <a:ext cx="10036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ilenc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emale mi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6537600" y="2440080"/>
              <a:ext cx="875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ilenc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ale mi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901880" y="3381480"/>
              <a:ext cx="14731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USVs detected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in mouse pair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057400" y="2424240"/>
              <a:ext cx="5486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057400" y="2881440"/>
              <a:ext cx="548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038680" y="2847960"/>
              <a:ext cx="12931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o. of mouse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airs teste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033440" y="29973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474880" y="29973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852600" y="299736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033440" y="35305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474880" y="35305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52600" y="35305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981080" y="3914640"/>
              <a:ext cx="5562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209680" y="1752480"/>
              <a:ext cx="4876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able S2. Only males emitted USVs during male-female interaction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942920" y="2514600"/>
              <a:ext cx="986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ice Pari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0T04:54:32Z</dcterms:created>
  <dc:creator>Mary X. Gao</dc:creator>
  <dc:description/>
  <dc:language>en-US</dc:language>
  <cp:lastModifiedBy>U of T</cp:lastModifiedBy>
  <dcterms:modified xsi:type="dcterms:W3CDTF">2008-02-28T17:10:11Z</dcterms:modified>
  <cp:revision>9</cp:revision>
  <dc:subject/>
  <dc:title>Slide 1</dc:title>
</cp:coreProperties>
</file>